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56" r:id="rId2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1"/>
    <p:restoredTop sz="78362"/>
  </p:normalViewPr>
  <p:slideViewPr>
    <p:cSldViewPr snapToGrid="0">
      <p:cViewPr varScale="1">
        <p:scale>
          <a:sx n="97" d="100"/>
          <a:sy n="97" d="100"/>
        </p:scale>
        <p:origin x="1608" y="1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D0F7316-B8DB-EB41-9575-5CDA876A4E64}" type="datetimeFigureOut">
              <a:rPr kumimoji="1" lang="ja-JP" altLang="en-US" smtClean="0"/>
              <a:t>2024/1/5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6DA3B66-B1C6-DF4A-BC5A-D3792C01102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7304708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09E4D32F-C476-8F05-B0B6-6034996961C6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0CBC1E03-15FC-E76F-EA71-772A8E320A41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22987154-43F7-BF43-2055-1336C28B1A8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69E23E-7F96-3344-B2E3-9BCB10D26B31}" type="datetimeFigureOut">
              <a:rPr kumimoji="1" lang="ja-JP" altLang="en-US" smtClean="0"/>
              <a:t>2024/1/5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CF50EA53-24A2-8C80-91D3-AED230887B6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77975A5E-F6D6-B581-A3E0-D38C4F308FE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4483B6-00D8-014E-B251-3AFBBCE8B56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7789133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23A877FF-F061-294C-FC7E-AEBCE38F899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40A34960-F4C4-51CA-1E33-BE04878E7F9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A519A5F7-CC5E-DE85-C811-E0364D156E6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69E23E-7F96-3344-B2E3-9BCB10D26B31}" type="datetimeFigureOut">
              <a:rPr kumimoji="1" lang="ja-JP" altLang="en-US" smtClean="0"/>
              <a:t>2024/1/5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B04323E0-7605-2C24-B394-F1A96BC73B9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13AD046F-550F-5915-90A2-9C128130C82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4483B6-00D8-014E-B251-3AFBBCE8B56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9075727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3A1A7FEA-5EE6-5678-C434-91DF4E33C764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CC6B2FE7-C6D8-6725-090B-C6DB1042D89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F0773F10-79B1-E5B7-1291-37A9C52A14F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69E23E-7F96-3344-B2E3-9BCB10D26B31}" type="datetimeFigureOut">
              <a:rPr kumimoji="1" lang="ja-JP" altLang="en-US" smtClean="0"/>
              <a:t>2024/1/5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90A80ABA-CCC4-5B24-01B7-10B1554C391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589E5965-958B-5E05-C32B-80D8CAB3467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4483B6-00D8-014E-B251-3AFBBCE8B56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3086488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36FFCC3B-8819-5F60-2DAE-BA4C837159E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702F50C4-1573-7E8E-FF1B-6428AE56758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6E1E5D84-21D9-85D0-8575-DD97E7FDCD4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69E23E-7F96-3344-B2E3-9BCB10D26B31}" type="datetimeFigureOut">
              <a:rPr kumimoji="1" lang="ja-JP" altLang="en-US" smtClean="0"/>
              <a:t>2024/1/5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50960226-B0DA-E311-E839-8F41FAB85E4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0868B052-541C-D6C2-B944-1DD64B59D17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4483B6-00D8-014E-B251-3AFBBCE8B56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9718139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CD9C9185-E807-9735-0952-F95A88CB71F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B8834234-6C63-EB9F-C636-5F95FC635FB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3BFE4909-37E2-62E9-1AF6-511D4E835E6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69E23E-7F96-3344-B2E3-9BCB10D26B31}" type="datetimeFigureOut">
              <a:rPr kumimoji="1" lang="ja-JP" altLang="en-US" smtClean="0"/>
              <a:t>2024/1/5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030378EB-9537-DBB0-BD47-4DCCCD7F831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B67D00FB-59C4-7CC6-93FE-91E42FFCD8C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4483B6-00D8-014E-B251-3AFBBCE8B56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1738303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83B74E74-C023-0FB1-04FB-E3D2D8CDB18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5401F11E-5610-C7F5-AF86-E22EF8EA12ED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FD55A9F2-718B-491F-34F5-3C864D41500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9B7836FF-D9D3-C1B4-833F-025A4FF91D6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69E23E-7F96-3344-B2E3-9BCB10D26B31}" type="datetimeFigureOut">
              <a:rPr kumimoji="1" lang="ja-JP" altLang="en-US" smtClean="0"/>
              <a:t>2024/1/5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3BE143DE-9F2C-544B-5739-6ACA574DB22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89187E8C-C68D-1BAB-34A1-816874D57CF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4483B6-00D8-014E-B251-3AFBBCE8B56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98362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398B1801-2230-F93B-2FC4-C934A4596E1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0666322E-8219-5B74-39A5-076F8031E89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B5B232A0-1ABB-346B-24F8-3B4148979E9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9E0FD978-17B9-387B-F1DB-3FEAC9141AB9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4D070A17-6DE0-31BF-113E-3052CD1FE403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70A534EE-4BF3-B156-A1A2-72E4821861E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69E23E-7F96-3344-B2E3-9BCB10D26B31}" type="datetimeFigureOut">
              <a:rPr kumimoji="1" lang="ja-JP" altLang="en-US" smtClean="0"/>
              <a:t>2024/1/5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4FD94A8A-53EF-F429-4E72-4492041777B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3555262C-73A4-F0A3-33FA-2E95215AA0F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4483B6-00D8-014E-B251-3AFBBCE8B56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9264215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EEE7BF33-A300-6002-5C84-D943641D409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C5F87FE9-021D-379E-1F47-58AAE1B63F8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69E23E-7F96-3344-B2E3-9BCB10D26B31}" type="datetimeFigureOut">
              <a:rPr kumimoji="1" lang="ja-JP" altLang="en-US" smtClean="0"/>
              <a:t>2024/1/5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3A171F41-58FC-FE84-B7AB-6DE87164B0E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923D133F-892C-7AB6-BAEA-92BC64E1E70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4483B6-00D8-014E-B251-3AFBBCE8B56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072966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2D6FCF41-B757-BB90-54F0-2F8B8980DC3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69E23E-7F96-3344-B2E3-9BCB10D26B31}" type="datetimeFigureOut">
              <a:rPr kumimoji="1" lang="ja-JP" altLang="en-US" smtClean="0"/>
              <a:t>2024/1/5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46A39C6D-2D4E-976E-C7F2-D9E6DAB2704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7020A8A6-7649-ECD3-D056-2A8EF7158CB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4483B6-00D8-014E-B251-3AFBBCE8B56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4174187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06C26801-4D27-EE58-E827-B7EEBEE81AD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D9AE6A3E-6641-BA14-5E1B-5E963FF89290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48512027-0F28-8EF7-3285-A7A5512167A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913F7361-6FAD-5075-7B54-D6456B737AE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69E23E-7F96-3344-B2E3-9BCB10D26B31}" type="datetimeFigureOut">
              <a:rPr kumimoji="1" lang="ja-JP" altLang="en-US" smtClean="0"/>
              <a:t>2024/1/5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00FF836B-EF0D-2FD5-51A1-497F611256B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5A172AF7-D1BE-0A05-1B89-6298888B842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4483B6-00D8-014E-B251-3AFBBCE8B56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4840985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CAF4F995-E6BB-BD4B-EEBC-3C12CFB2A0F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D3FB6FCD-61AA-9199-0495-A471C58472C5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5F5916E9-C835-3080-357B-921F690DF14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B0CFC92D-A535-F995-E9C4-436C5FFB0F7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69E23E-7F96-3344-B2E3-9BCB10D26B31}" type="datetimeFigureOut">
              <a:rPr kumimoji="1" lang="ja-JP" altLang="en-US" smtClean="0"/>
              <a:t>2024/1/5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61B7B2F3-B70D-3AB6-1A1E-AFABECE895E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E0E8372B-ECB0-6E46-C92E-9C8AEFEF6F7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4483B6-00D8-014E-B251-3AFBBCE8B56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0340181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B06AF146-F991-7490-C251-E3B4308A3ED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6D9ED067-C63A-A0D7-6047-D29C1C2492C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D06FF7D0-8928-557D-2093-9EF36F385FC7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269E23E-7F96-3344-B2E3-9BCB10D26B31}" type="datetimeFigureOut">
              <a:rPr kumimoji="1" lang="ja-JP" altLang="en-US" smtClean="0"/>
              <a:t>2024/1/5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8CF48996-453F-30B3-3134-C1B7E7701790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BA22FEFF-83E2-17EF-2E14-D13C8AA70E0B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44483B6-00D8-014E-B251-3AFBBCE8B56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4779083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図 4">
            <a:extLst>
              <a:ext uri="{FF2B5EF4-FFF2-40B4-BE49-F238E27FC236}">
                <a16:creationId xmlns:a16="http://schemas.microsoft.com/office/drawing/2014/main" id="{AEAB1A2D-F34A-70B7-C592-03713389EA97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t="4676"/>
          <a:stretch/>
        </p:blipFill>
        <p:spPr>
          <a:xfrm>
            <a:off x="315153" y="1272208"/>
            <a:ext cx="4296603" cy="5460919"/>
          </a:xfrm>
          <a:prstGeom prst="rect">
            <a:avLst/>
          </a:prstGeom>
        </p:spPr>
      </p:pic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99D082E6-495F-75BC-A96C-A082DA40B405}"/>
              </a:ext>
            </a:extLst>
          </p:cNvPr>
          <p:cNvSpPr txBox="1"/>
          <p:nvPr/>
        </p:nvSpPr>
        <p:spPr>
          <a:xfrm>
            <a:off x="315154" y="367276"/>
            <a:ext cx="1156169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b="1" dirty="0">
                <a:latin typeface="Helvetica" pitchFamily="2" charset="0"/>
              </a:rPr>
              <a:t>Figure S2. </a:t>
            </a:r>
            <a:r>
              <a:rPr lang="en-US" altLang="ja-JP" sz="1600" b="1" i="1" dirty="0">
                <a:effectLst/>
                <a:latin typeface="Helvetica" pitchFamily="2" charset="0"/>
                <a:ea typeface="游明朝" panose="02020400000000000000" pitchFamily="18" charset="-128"/>
              </a:rPr>
              <a:t>TMEM260 </a:t>
            </a:r>
            <a:r>
              <a:rPr lang="en-US" altLang="ja-JP" sz="1600" b="1" dirty="0">
                <a:effectLst/>
                <a:latin typeface="Helvetica" pitchFamily="2" charset="0"/>
                <a:ea typeface="游明朝" panose="02020400000000000000" pitchFamily="18" charset="-128"/>
              </a:rPr>
              <a:t>mRNA expression was significantly decreased in the cases with homozygous c.1617del variant</a:t>
            </a:r>
            <a:r>
              <a:rPr lang="ja-JP" altLang="ja-JP" sz="1600" b="1">
                <a:effectLst/>
                <a:latin typeface="Helvetica" pitchFamily="2" charset="0"/>
              </a:rPr>
              <a:t> </a:t>
            </a:r>
            <a:endParaRPr kumimoji="1" lang="ja-JP" altLang="en-US" sz="1600" b="1" dirty="0">
              <a:latin typeface="Helvetica" pitchFamily="2" charset="0"/>
            </a:endParaRPr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F7AF4C7F-90DA-CBC1-3386-99FF86BB1761}"/>
              </a:ext>
            </a:extLst>
          </p:cNvPr>
          <p:cNvSpPr txBox="1"/>
          <p:nvPr/>
        </p:nvSpPr>
        <p:spPr>
          <a:xfrm>
            <a:off x="1461416" y="964431"/>
            <a:ext cx="200407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b="1" i="1" dirty="0">
                <a:effectLst/>
                <a:latin typeface="Helvetica" pitchFamily="2" charset="0"/>
                <a:ea typeface="游明朝" panose="02020400000000000000" pitchFamily="18" charset="-128"/>
              </a:rPr>
              <a:t>TMEM260 </a:t>
            </a:r>
            <a:r>
              <a:rPr lang="en-US" altLang="ja-JP" sz="1400" b="1" dirty="0">
                <a:effectLst/>
                <a:latin typeface="Helvetica" pitchFamily="2" charset="0"/>
                <a:ea typeface="游明朝" panose="02020400000000000000" pitchFamily="18" charset="-128"/>
              </a:rPr>
              <a:t>expression</a:t>
            </a:r>
            <a:endParaRPr kumimoji="1" lang="ja-JP" altLang="en-US" sz="1400" b="1" dirty="0">
              <a:latin typeface="Helvetica" pitchFamily="2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69241272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0</TotalTime>
  <Words>20</Words>
  <Application>Microsoft Macintosh PowerPoint</Application>
  <PresentationFormat>ワイド画面</PresentationFormat>
  <Paragraphs>2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游ゴシック</vt:lpstr>
      <vt:lpstr>游ゴシック Light</vt:lpstr>
      <vt:lpstr>Arial</vt:lpstr>
      <vt:lpstr>Helvetica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忠 井上</dc:creator>
  <cp:lastModifiedBy>忠 井上</cp:lastModifiedBy>
  <cp:revision>7</cp:revision>
  <dcterms:created xsi:type="dcterms:W3CDTF">2023-11-16T03:11:09Z</dcterms:created>
  <dcterms:modified xsi:type="dcterms:W3CDTF">2024-01-05T04:12:06Z</dcterms:modified>
</cp:coreProperties>
</file>